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4" d="100"/>
          <a:sy n="64" d="100"/>
        </p:scale>
        <p:origin x="64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51C3F8-804C-484C-8217-34CAD8D6E75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3D8485E-68E6-4CD7-AA11-85DDA6EBF8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EF5AEF-67A1-48D4-9703-61592F0A7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C04BF3-6F32-4F10-AA72-5559D9C96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DB6CB9-245A-4143-B945-2C4D44BA3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6812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587B57-9A92-49EC-A74A-15C61523EA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34A292D-C855-489D-A174-A205707E76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545B06B-FC4C-4D5C-B15F-35DA3A489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242355-7D37-4E86-B856-2117E2824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B6D1ABE-148D-4660-B87E-3F55070909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3332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1ABC90F-9DAB-41EB-AA42-A8D641EBAA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9A530C0-28AB-4113-8C37-71536E707B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25384DC-123B-40D9-96F8-76D7A03B18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049F28-6635-4140-89DA-0A2638849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00C040-68FC-4B34-AC64-98E850AE7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6352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B52ADC-39B4-4D6B-A7DA-0C87660A7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50ECE0A-5120-4D20-B1C3-B09BFF8DBC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3B5B65-45A9-4E92-BB51-71E20A11E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5C4105B-E131-42A4-AD15-76696D24B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FAEC55-8B03-4573-ADEC-A000725543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1906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491A77-AA44-43C9-935F-A9079D6DF0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2928A6C-2C30-4284-8B14-6BCE2D7C55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64110E-1BF3-47EA-9276-A070621AD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CD6240-8BBC-4F2B-9B5E-4AF0B2DEBD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9AC393-B6BF-44C8-BDA7-6C92844E2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8827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5146CA-E924-4430-9C28-FC1254B2FC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B2F701B-BADC-4CE3-A5FA-DAE6269236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E2DB02D-3EF0-417E-A40D-024EA15632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99CE9DD-66F5-450F-AFE7-DE429C6B5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4595A94-9ED5-4E5C-BEFC-04A267978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C43F3F-F961-4FB2-A575-BCDE8EFE30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88139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1DE70B-40F2-4150-8CDB-55A9D5EE1A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E121403-0A5C-40B9-AF98-B6302784B8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13C4358-E03E-4389-BA19-E67D82EF1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D09373E-2B5F-434F-A50D-0752FC658B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DE85EBD-71AC-40C7-8E30-83A4194A3C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70D7BAE-2A42-4345-B2F2-A3B50A0729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BFA3F8B-959B-4E60-A5FD-CD3839EAD8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AFE8CDE-E61A-4C70-8909-EAACAF948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1957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B98B61-D044-417A-83D6-13F21BEDD2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95E08C8-2163-436B-954A-F054B42ABE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CF79BDE-E40D-4C3C-A0D8-6A2F000DE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3B650D4-811E-4CF5-B16E-2F1668D47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1075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818BEE7-6BE9-4B4C-B861-6EBEBEC0FE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93CC433-BBCD-4B06-8945-18D50D2B7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F15D995-2DF5-4628-9AD7-704CAAEF6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5750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F425D9-9C87-4F36-8BAF-D70B057B4D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6673D06-34D6-4FCD-9816-1D85A2A146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80E641B-B04D-472A-9D2D-3F8151382C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25545BF-5746-4FAC-8958-09D0CEB3BE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50EF30F-FE7D-48C8-89CF-F1810A5BEE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A5DED02-1554-46ED-9470-391564605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4649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20D1A4-2F1D-424C-9E4A-2CFCEC3EC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433D4C2-BB70-44C6-B31A-8DA37FE65D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8B0A4EC-323C-499B-8439-342CDFD371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17D2A33-B3BB-4A88-9420-F26644116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A8BC78-56A1-44E1-B655-D9940AC2C5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7EB2C2-EC17-4BD1-A936-DD2F10872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62451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180BA05-E427-4BDB-BE37-08250BE6D1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61AE0FB-F3E4-4867-8D6B-D4DDF53AD8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EE5890-2FC2-44A4-849C-84126CA1AA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6CD792-9E14-4D8C-BFDF-14ECC7C28290}" type="datetimeFigureOut">
              <a:rPr lang="zh-CN" altLang="en-US" smtClean="0"/>
              <a:t>2022/1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ACE779-0285-45F8-AD24-DA1E484378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499FE0-8381-418D-9B42-F39048EFBF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57D737-2DD8-40AE-A60C-A33F13CE6DB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9475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: 圆角 4">
            <a:extLst>
              <a:ext uri="{FF2B5EF4-FFF2-40B4-BE49-F238E27FC236}">
                <a16:creationId xmlns:a16="http://schemas.microsoft.com/office/drawing/2014/main" id="{48352AE3-31E0-4B02-918B-7576DFAF44F4}"/>
              </a:ext>
            </a:extLst>
          </p:cNvPr>
          <p:cNvSpPr/>
          <p:nvPr/>
        </p:nvSpPr>
        <p:spPr>
          <a:xfrm>
            <a:off x="1167018" y="2406655"/>
            <a:ext cx="1827723" cy="1757238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prospective cohort of 163 ESRD patients who began to hemodialysis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箭头: 右 5">
            <a:extLst>
              <a:ext uri="{FF2B5EF4-FFF2-40B4-BE49-F238E27FC236}">
                <a16:creationId xmlns:a16="http://schemas.microsoft.com/office/drawing/2014/main" id="{019F3D06-5504-40D2-8379-EF3B40F839AA}"/>
              </a:ext>
            </a:extLst>
          </p:cNvPr>
          <p:cNvSpPr/>
          <p:nvPr/>
        </p:nvSpPr>
        <p:spPr>
          <a:xfrm>
            <a:off x="2988943" y="3076886"/>
            <a:ext cx="962108" cy="55659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D9048A57-E9E9-4A69-96B9-3CDE522537FC}"/>
              </a:ext>
            </a:extLst>
          </p:cNvPr>
          <p:cNvSpPr/>
          <p:nvPr/>
        </p:nvSpPr>
        <p:spPr>
          <a:xfrm>
            <a:off x="782044" y="220978"/>
            <a:ext cx="9835763" cy="68381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aseline ratio of soluble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a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/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asL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redicts onset of pulmonary hypertension in older patients undergoing maintenance hemodialysis: a prospective cohort study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矩形: 圆角 7">
            <a:extLst>
              <a:ext uri="{FF2B5EF4-FFF2-40B4-BE49-F238E27FC236}">
                <a16:creationId xmlns:a16="http://schemas.microsoft.com/office/drawing/2014/main" id="{F1BBA3E8-A399-46BA-8EC1-C6E2BF704C2E}"/>
              </a:ext>
            </a:extLst>
          </p:cNvPr>
          <p:cNvSpPr/>
          <p:nvPr/>
        </p:nvSpPr>
        <p:spPr>
          <a:xfrm>
            <a:off x="3945253" y="1227703"/>
            <a:ext cx="3059929" cy="96757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mographic data and history of medicine 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: 圆角 10">
            <a:extLst>
              <a:ext uri="{FF2B5EF4-FFF2-40B4-BE49-F238E27FC236}">
                <a16:creationId xmlns:a16="http://schemas.microsoft.com/office/drawing/2014/main" id="{6A060ABE-0ECB-42EC-BD9A-8C2DE060C4A8}"/>
              </a:ext>
            </a:extLst>
          </p:cNvPr>
          <p:cNvSpPr/>
          <p:nvPr/>
        </p:nvSpPr>
        <p:spPr>
          <a:xfrm>
            <a:off x="3945253" y="2330455"/>
            <a:ext cx="3059929" cy="96757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s of hemodynamics</a:t>
            </a:r>
          </a:p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chocardiography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: 圆角 11">
            <a:extLst>
              <a:ext uri="{FF2B5EF4-FFF2-40B4-BE49-F238E27FC236}">
                <a16:creationId xmlns:a16="http://schemas.microsoft.com/office/drawing/2014/main" id="{03F5B8F8-DE89-442F-B167-63B530FDDF97}"/>
              </a:ext>
            </a:extLst>
          </p:cNvPr>
          <p:cNvSpPr/>
          <p:nvPr/>
        </p:nvSpPr>
        <p:spPr>
          <a:xfrm>
            <a:off x="3945253" y="3433207"/>
            <a:ext cx="3060000" cy="96757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s of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as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FasL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iver functions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: 圆角 12">
            <a:extLst>
              <a:ext uri="{FF2B5EF4-FFF2-40B4-BE49-F238E27FC236}">
                <a16:creationId xmlns:a16="http://schemas.microsoft.com/office/drawing/2014/main" id="{558EBF80-ED33-49B8-9A33-286271191C60}"/>
              </a:ext>
            </a:extLst>
          </p:cNvPr>
          <p:cNvSpPr/>
          <p:nvPr/>
        </p:nvSpPr>
        <p:spPr>
          <a:xfrm>
            <a:off x="8469139" y="2878001"/>
            <a:ext cx="1630017" cy="1009816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 assessment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5E7A587-6CEF-4EA6-AEDA-5BCE5D0719C6}"/>
              </a:ext>
            </a:extLst>
          </p:cNvPr>
          <p:cNvSpPr txBox="1"/>
          <p:nvPr/>
        </p:nvSpPr>
        <p:spPr>
          <a:xfrm>
            <a:off x="6909932" y="2226805"/>
            <a:ext cx="172145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median </a:t>
            </a:r>
          </a:p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5.5 years’</a:t>
            </a:r>
          </a:p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low-up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: 圆角 15">
            <a:extLst>
              <a:ext uri="{FF2B5EF4-FFF2-40B4-BE49-F238E27FC236}">
                <a16:creationId xmlns:a16="http://schemas.microsoft.com/office/drawing/2014/main" id="{E3C262F6-F044-4F52-B04F-D5C0B11692F2}"/>
              </a:ext>
            </a:extLst>
          </p:cNvPr>
          <p:cNvSpPr/>
          <p:nvPr/>
        </p:nvSpPr>
        <p:spPr>
          <a:xfrm>
            <a:off x="3945253" y="4527703"/>
            <a:ext cx="3060000" cy="967577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lines of residual renal function and serum ions pre-and post dialysi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箭头: 右 16">
            <a:extLst>
              <a:ext uri="{FF2B5EF4-FFF2-40B4-BE49-F238E27FC236}">
                <a16:creationId xmlns:a16="http://schemas.microsoft.com/office/drawing/2014/main" id="{0EBC4EA0-993B-4B8E-A94E-A3F2DBBEDE3B}"/>
              </a:ext>
            </a:extLst>
          </p:cNvPr>
          <p:cNvSpPr/>
          <p:nvPr/>
        </p:nvSpPr>
        <p:spPr>
          <a:xfrm>
            <a:off x="7060590" y="3097192"/>
            <a:ext cx="1372262" cy="55659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箭头: 右 17">
            <a:extLst>
              <a:ext uri="{FF2B5EF4-FFF2-40B4-BE49-F238E27FC236}">
                <a16:creationId xmlns:a16="http://schemas.microsoft.com/office/drawing/2014/main" id="{DAD4FCA2-90E1-4A4F-B07B-4574C7C67FFD}"/>
              </a:ext>
            </a:extLst>
          </p:cNvPr>
          <p:cNvSpPr/>
          <p:nvPr/>
        </p:nvSpPr>
        <p:spPr>
          <a:xfrm rot="5400000">
            <a:off x="8978791" y="3915480"/>
            <a:ext cx="610709" cy="556591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: 圆角 18">
            <a:extLst>
              <a:ext uri="{FF2B5EF4-FFF2-40B4-BE49-F238E27FC236}">
                <a16:creationId xmlns:a16="http://schemas.microsoft.com/office/drawing/2014/main" id="{A69D815A-1BDE-4CDB-A698-4F6729D2C6BE}"/>
              </a:ext>
            </a:extLst>
          </p:cNvPr>
          <p:cNvSpPr/>
          <p:nvPr/>
        </p:nvSpPr>
        <p:spPr>
          <a:xfrm>
            <a:off x="8507239" y="4518178"/>
            <a:ext cx="1630017" cy="1009816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risk factor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7E4DB829-82AB-4331-B000-1B2DFE068947}"/>
              </a:ext>
            </a:extLst>
          </p:cNvPr>
          <p:cNvSpPr/>
          <p:nvPr/>
        </p:nvSpPr>
        <p:spPr>
          <a:xfrm>
            <a:off x="765311" y="5850906"/>
            <a:ext cx="9835763" cy="68381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baseline ratio of 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Fas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/</a:t>
            </a:r>
            <a:r>
              <a:rPr lang="en-US" altLang="zh-CN" sz="1800" b="1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asL</a:t>
            </a: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RV, LVPW, and post-dialysis K+ were independent risk factors for PH onset, while post-dialysis LVEF was a protective factor for PH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A21E654-5B40-44C0-9A37-89DB7F84C1C3}"/>
              </a:ext>
            </a:extLst>
          </p:cNvPr>
          <p:cNvSpPr txBox="1"/>
          <p:nvPr/>
        </p:nvSpPr>
        <p:spPr>
          <a:xfrm>
            <a:off x="9146824" y="3856072"/>
            <a:ext cx="24413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 analyse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3898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>
        <a:spAutoFit/>
      </a:bodyPr>
      <a:lstStyle>
        <a:defPPr algn="ctr">
          <a:defRPr dirty="0">
            <a:solidFill>
              <a:srgbClr val="FF0000"/>
            </a:solidFill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</TotalTime>
  <Words>113</Words>
  <Application>Microsoft Office PowerPoint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000</dc:creator>
  <cp:lastModifiedBy>000</cp:lastModifiedBy>
  <cp:revision>30</cp:revision>
  <dcterms:created xsi:type="dcterms:W3CDTF">2021-01-18T10:52:52Z</dcterms:created>
  <dcterms:modified xsi:type="dcterms:W3CDTF">2022-01-01T06:08:09Z</dcterms:modified>
</cp:coreProperties>
</file>